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983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8C278AD-2E5B-41D4-A0C1-4F55E27AAD11}" v="35" dt="2022-04-22T11:42:26.66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29A2529-6D64-4E6C-A9EC-C85270A60E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FF479049-A8BB-47F5-BD23-C32A02A236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E04AEB4-6A9F-41DE-BE01-DC82F6E72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F07734-D66E-4984-9A5B-923441CB9C53}" type="datetimeFigureOut">
              <a:rPr lang="fr-FR" smtClean="0"/>
              <a:t>29/08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E8A6388-BE08-4422-8B92-E2F3C82BE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DE3FE23-4CBD-4E58-A8E4-70AE555C5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90DA9-2E4A-45AC-8ADA-07792A1D71FD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8369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82AC86C-DDE7-4337-AD27-9583262B60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FDB82C2-95EC-4E4A-AECC-FEB74C903F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6F1D46F-1549-403A-92E0-FD306C088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F07734-D66E-4984-9A5B-923441CB9C53}" type="datetimeFigureOut">
              <a:rPr lang="fr-FR" smtClean="0"/>
              <a:t>29/08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0940F7A-0759-497A-81EF-8815E3157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6E05334-DA24-49E5-9C9A-950920A1C3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90DA9-2E4A-45AC-8ADA-07792A1D71FD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57808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9FBEBC7B-ABCE-4A98-B4D9-727EE71C8C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8DD9E5B-9071-4601-A80A-0DCE9FE7A4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8AC694D-7278-487C-8AA2-D6152523A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F07734-D66E-4984-9A5B-923441CB9C53}" type="datetimeFigureOut">
              <a:rPr lang="fr-FR" smtClean="0"/>
              <a:t>29/08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06B41D3-0253-4275-93F3-27A5E3E4D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349F23C-71DD-4EDC-9DD4-D588B3EF2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90DA9-2E4A-45AC-8ADA-07792A1D71FD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244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F8FC3F0-779C-47DE-9438-0EB4DA7D0C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33138A-0F64-43D5-86C9-277F95E5EE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D71E402-C255-4FA3-A6E6-8FC3373DF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F07734-D66E-4984-9A5B-923441CB9C53}" type="datetimeFigureOut">
              <a:rPr lang="fr-FR" smtClean="0"/>
              <a:t>29/08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EB52FBE-D1E4-410A-A4D1-CF563966F2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622BFCA-C5D2-4265-A3C5-07BC9FD2A0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90DA9-2E4A-45AC-8ADA-07792A1D71FD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6886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39167C3-95BE-451A-ACA6-C831C52A40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BEE941E-53DC-44B1-9A36-F4FB8B9BEE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32E2F6D-5BBF-4555-8E50-F67FA4F5DB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F07734-D66E-4984-9A5B-923441CB9C53}" type="datetimeFigureOut">
              <a:rPr lang="fr-FR" smtClean="0"/>
              <a:t>29/08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894FC46-EDFC-4F6F-BD7B-F87C9239ED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E6373C8-9EB3-4FC5-BD29-7FFC8885FC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90DA9-2E4A-45AC-8ADA-07792A1D71FD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3337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6C719FD-2F9D-4D39-BABA-C52FA4B834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254B5DE-CE3A-4C5D-BA56-8E71591AF7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8D91BF4-B463-4394-A72F-3F9551EFA4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DDD52F0-1DAA-4B03-8547-F9698979F1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F07734-D66E-4984-9A5B-923441CB9C53}" type="datetimeFigureOut">
              <a:rPr lang="fr-FR" smtClean="0"/>
              <a:t>29/08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C408B73-0C56-4D27-8374-B1F169E31B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A69DE59-4600-4060-8A83-E24FFF74B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90DA9-2E4A-45AC-8ADA-07792A1D71FD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1620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5A964A5-54CF-4BE6-A398-3179950BE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2E64AFB-57A3-49C5-9F82-8A2E90840E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3462211-D421-4EC8-B7B9-90CC10DF68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DDF37DD8-9F5F-445B-9086-7130A1ED5A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54629503-A89A-475F-8EF4-B2AED5ABCE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698DB3A9-9A4D-414D-9D46-5851E3B60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F07734-D66E-4984-9A5B-923441CB9C53}" type="datetimeFigureOut">
              <a:rPr lang="fr-FR" smtClean="0"/>
              <a:t>29/08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7F710001-7B2A-40E6-8F91-22224A060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C9EB028-412B-481C-82C6-1EA9F8F00A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90DA9-2E4A-45AC-8ADA-07792A1D71FD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7734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78EAF45-BA7C-4E47-A922-583B50EA2A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455ED99-F904-41D2-8387-666A39AFB4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F07734-D66E-4984-9A5B-923441CB9C53}" type="datetimeFigureOut">
              <a:rPr lang="fr-FR" smtClean="0"/>
              <a:t>29/08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A77996B-AF6F-46B6-976F-9D4E0FFEBA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5A64963-C221-4CEF-9B0B-9CA8D2679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90DA9-2E4A-45AC-8ADA-07792A1D71FD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06868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67BB104-6E3D-4420-9016-2EBEE428F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F07734-D66E-4984-9A5B-923441CB9C53}" type="datetimeFigureOut">
              <a:rPr lang="fr-FR" smtClean="0"/>
              <a:t>29/08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21D8B261-BF6B-426F-AE84-705EC7F9F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854E8C3-24D2-425B-953E-D42098A1BD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90DA9-2E4A-45AC-8ADA-07792A1D71FD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4506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9D81E5A-FA08-42D2-AD09-5A98F9BF96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17A2F03-14AC-44B6-B006-5FA5C9DB9D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722CA8E-437C-46DE-BE18-44FAE06C2D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5EB5665-7BBD-4492-AE84-16B7A8503F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F07734-D66E-4984-9A5B-923441CB9C53}" type="datetimeFigureOut">
              <a:rPr lang="fr-FR" smtClean="0"/>
              <a:t>29/08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8B4675F-F872-4064-A9B0-58BB242FB7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28C6323-B1CD-4AF7-AB1A-F1A727DE2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90DA9-2E4A-45AC-8ADA-07792A1D71FD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4274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DB4A2A5-3007-4525-B5BB-6653504CC7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945ECEB-3B6A-4A50-87B0-9E638F6C4E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6D26363-C81E-4459-A79B-5398A2C486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8C2F04C-2B17-491C-ABD7-8BB777DBC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F07734-D66E-4984-9A5B-923441CB9C53}" type="datetimeFigureOut">
              <a:rPr lang="fr-FR" smtClean="0"/>
              <a:t>29/08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200ECAE-9D0A-48A1-858D-BB31DE738C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91D347B-BFA4-4490-8BF3-37B1463594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90DA9-2E4A-45AC-8ADA-07792A1D71FD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8051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57BC30F-BF27-43E4-A931-6C0AAEF6E3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35E5C03-1A0B-4C2C-AE03-BB44FA06BB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F43CB60-ADCB-466A-844A-762677E8C2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F07734-D66E-4984-9A5B-923441CB9C53}" type="datetimeFigureOut">
              <a:rPr lang="fr-FR" smtClean="0"/>
              <a:t>29/08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9526C2-2A9E-4AE0-9816-B4F00BE561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4556927-4E1B-4429-A01D-EE786DD129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790DA9-2E4A-45AC-8ADA-07792A1D71FD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21455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feld 25"/>
          <p:cNvSpPr txBox="1"/>
          <p:nvPr/>
        </p:nvSpPr>
        <p:spPr>
          <a:xfrm rot="18110173">
            <a:off x="5260921" y="1328508"/>
            <a:ext cx="11214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Hox</a:t>
            </a:r>
            <a:r>
              <a:rPr lang="de-DE" sz="1400" dirty="0"/>
              <a:t> WT</a:t>
            </a:r>
          </a:p>
        </p:txBody>
      </p:sp>
      <p:sp>
        <p:nvSpPr>
          <p:cNvPr id="27" name="Textfeld 26"/>
          <p:cNvSpPr txBox="1"/>
          <p:nvPr/>
        </p:nvSpPr>
        <p:spPr>
          <a:xfrm rot="18110173">
            <a:off x="2443642" y="1282588"/>
            <a:ext cx="12295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rotein </a:t>
            </a:r>
            <a:r>
              <a:rPr lang="de-DE" sz="1400" dirty="0" err="1"/>
              <a:t>ladder</a:t>
            </a:r>
            <a:endParaRPr lang="de-DE" sz="1400" dirty="0"/>
          </a:p>
        </p:txBody>
      </p:sp>
      <p:sp>
        <p:nvSpPr>
          <p:cNvPr id="40" name="Rechteck 31">
            <a:extLst>
              <a:ext uri="{FF2B5EF4-FFF2-40B4-BE49-F238E27FC236}">
                <a16:creationId xmlns:a16="http://schemas.microsoft.com/office/drawing/2014/main" id="{A1557FB2-291C-4AF6-BA4B-F7785B700DD1}"/>
              </a:ext>
            </a:extLst>
          </p:cNvPr>
          <p:cNvSpPr/>
          <p:nvPr/>
        </p:nvSpPr>
        <p:spPr>
          <a:xfrm>
            <a:off x="8779141" y="2253595"/>
            <a:ext cx="234605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de-DE" sz="800" dirty="0">
              <a:solidFill>
                <a:srgbClr val="000000"/>
              </a:solidFill>
              <a:latin typeface="AAAAA E+ Optima"/>
            </a:endParaRPr>
          </a:p>
          <a:p>
            <a:r>
              <a:rPr lang="de-DE" sz="1400" b="1" dirty="0">
                <a:solidFill>
                  <a:srgbClr val="000000"/>
                </a:solidFill>
                <a:latin typeface="AAAAA E+ Optima"/>
              </a:rPr>
              <a:t>VCP : ~90 </a:t>
            </a:r>
            <a:r>
              <a:rPr lang="de-DE" sz="1400" b="1" dirty="0" err="1">
                <a:solidFill>
                  <a:srgbClr val="000000"/>
                </a:solidFill>
                <a:latin typeface="AAAAA E+ Optima"/>
              </a:rPr>
              <a:t>kDa</a:t>
            </a:r>
            <a:endParaRPr lang="de-DE" sz="1400" b="1" dirty="0">
              <a:solidFill>
                <a:srgbClr val="000000"/>
              </a:solidFill>
              <a:latin typeface="AAAAA E+ Optima"/>
            </a:endParaRPr>
          </a:p>
          <a:p>
            <a:r>
              <a:rPr lang="de-DE" sz="1400" b="1" dirty="0">
                <a:solidFill>
                  <a:srgbClr val="000000"/>
                </a:solidFill>
                <a:latin typeface="AAAAA E+ Optima"/>
              </a:rPr>
              <a:t>1:5000</a:t>
            </a:r>
          </a:p>
        </p:txBody>
      </p:sp>
      <p:sp>
        <p:nvSpPr>
          <p:cNvPr id="22" name="Rechteck 31">
            <a:extLst>
              <a:ext uri="{FF2B5EF4-FFF2-40B4-BE49-F238E27FC236}">
                <a16:creationId xmlns:a16="http://schemas.microsoft.com/office/drawing/2014/main" id="{3AA1602E-CCD5-4771-BC15-175FB9E9C1B4}"/>
              </a:ext>
            </a:extLst>
          </p:cNvPr>
          <p:cNvSpPr/>
          <p:nvPr/>
        </p:nvSpPr>
        <p:spPr>
          <a:xfrm>
            <a:off x="8779142" y="4724059"/>
            <a:ext cx="207711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de-DE" sz="1400" b="1" dirty="0">
              <a:solidFill>
                <a:srgbClr val="000000"/>
              </a:solidFill>
              <a:latin typeface="AAAAA E+ Optima"/>
            </a:endParaRPr>
          </a:p>
          <a:p>
            <a:r>
              <a:rPr lang="de-DE" sz="1400" b="1" dirty="0">
                <a:solidFill>
                  <a:srgbClr val="000000"/>
                </a:solidFill>
                <a:latin typeface="AAAAA E+ Optima"/>
              </a:rPr>
              <a:t>LC3-II : ~14-15 </a:t>
            </a:r>
            <a:r>
              <a:rPr lang="de-DE" sz="1400" b="1" dirty="0" err="1">
                <a:solidFill>
                  <a:srgbClr val="000000"/>
                </a:solidFill>
                <a:latin typeface="AAAAA E+ Optima"/>
              </a:rPr>
              <a:t>kDa</a:t>
            </a:r>
            <a:endParaRPr lang="de-DE" sz="1400" b="1" dirty="0">
              <a:solidFill>
                <a:srgbClr val="000000"/>
              </a:solidFill>
              <a:latin typeface="AAAAA E+ Optima"/>
            </a:endParaRPr>
          </a:p>
          <a:p>
            <a:r>
              <a:rPr lang="de-DE" sz="1400" b="1" dirty="0">
                <a:solidFill>
                  <a:srgbClr val="000000"/>
                </a:solidFill>
                <a:latin typeface="AAAAA E+ Optima"/>
              </a:rPr>
              <a:t>1:5000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BC7F2EF6-21A3-41CC-A1AA-82286F661661}"/>
              </a:ext>
            </a:extLst>
          </p:cNvPr>
          <p:cNvSpPr txBox="1"/>
          <p:nvPr/>
        </p:nvSpPr>
        <p:spPr>
          <a:xfrm>
            <a:off x="462211" y="129906"/>
            <a:ext cx="5359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Source data (</a:t>
            </a:r>
            <a:r>
              <a:rPr lang="fr-FR" b="1" dirty="0" err="1"/>
              <a:t>entire</a:t>
            </a:r>
            <a:r>
              <a:rPr lang="fr-FR" b="1" dirty="0"/>
              <a:t> blot) for Figure 5C.</a:t>
            </a: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4A7A54F7-8EFA-433F-9422-FCFD7E6C8B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570" y="1398204"/>
            <a:ext cx="1845791" cy="4614478"/>
          </a:xfrm>
          <a:prstGeom prst="rect">
            <a:avLst/>
          </a:prstGeom>
        </p:spPr>
      </p:pic>
      <p:sp>
        <p:nvSpPr>
          <p:cNvPr id="25" name="Textfeld 25">
            <a:extLst>
              <a:ext uri="{FF2B5EF4-FFF2-40B4-BE49-F238E27FC236}">
                <a16:creationId xmlns:a16="http://schemas.microsoft.com/office/drawing/2014/main" id="{67059B6C-CC9F-4828-A76B-10ED39C8D263}"/>
              </a:ext>
            </a:extLst>
          </p:cNvPr>
          <p:cNvSpPr txBox="1"/>
          <p:nvPr/>
        </p:nvSpPr>
        <p:spPr>
          <a:xfrm rot="18110173">
            <a:off x="6643763" y="1276958"/>
            <a:ext cx="11718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Hox</a:t>
            </a:r>
            <a:r>
              <a:rPr lang="de-DE" sz="1400" dirty="0"/>
              <a:t> WT</a:t>
            </a:r>
          </a:p>
        </p:txBody>
      </p:sp>
      <p:sp>
        <p:nvSpPr>
          <p:cNvPr id="34" name="Textfeld 37">
            <a:extLst>
              <a:ext uri="{FF2B5EF4-FFF2-40B4-BE49-F238E27FC236}">
                <a16:creationId xmlns:a16="http://schemas.microsoft.com/office/drawing/2014/main" id="{E0585A8F-CB81-4577-A944-546641D4825D}"/>
              </a:ext>
            </a:extLst>
          </p:cNvPr>
          <p:cNvSpPr txBox="1"/>
          <p:nvPr/>
        </p:nvSpPr>
        <p:spPr>
          <a:xfrm rot="18110173">
            <a:off x="7267549" y="1307813"/>
            <a:ext cx="1160148" cy="3136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Hox</a:t>
            </a:r>
            <a:r>
              <a:rPr lang="de-DE" sz="1400" dirty="0"/>
              <a:t> URE</a:t>
            </a:r>
          </a:p>
        </p:txBody>
      </p:sp>
      <p:sp>
        <p:nvSpPr>
          <p:cNvPr id="42" name="Textfeld 37">
            <a:extLst>
              <a:ext uri="{FF2B5EF4-FFF2-40B4-BE49-F238E27FC236}">
                <a16:creationId xmlns:a16="http://schemas.microsoft.com/office/drawing/2014/main" id="{DB815542-9D71-4A9B-94BF-0080BB75C3BC}"/>
              </a:ext>
            </a:extLst>
          </p:cNvPr>
          <p:cNvSpPr txBox="1"/>
          <p:nvPr/>
        </p:nvSpPr>
        <p:spPr>
          <a:xfrm rot="18110173">
            <a:off x="5955259" y="1324898"/>
            <a:ext cx="11490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Hox</a:t>
            </a:r>
            <a:r>
              <a:rPr lang="de-DE" sz="1400" dirty="0"/>
              <a:t> URE</a:t>
            </a:r>
          </a:p>
        </p:txBody>
      </p:sp>
      <p:sp>
        <p:nvSpPr>
          <p:cNvPr id="43" name="Textfeld 25">
            <a:extLst>
              <a:ext uri="{FF2B5EF4-FFF2-40B4-BE49-F238E27FC236}">
                <a16:creationId xmlns:a16="http://schemas.microsoft.com/office/drawing/2014/main" id="{DC69B758-5F17-48B4-A6DD-32823ECB136C}"/>
              </a:ext>
            </a:extLst>
          </p:cNvPr>
          <p:cNvSpPr txBox="1"/>
          <p:nvPr/>
        </p:nvSpPr>
        <p:spPr>
          <a:xfrm rot="18110173">
            <a:off x="3831332" y="1349744"/>
            <a:ext cx="1090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Hox</a:t>
            </a:r>
            <a:r>
              <a:rPr lang="de-DE" sz="1400" dirty="0"/>
              <a:t> WT</a:t>
            </a:r>
          </a:p>
        </p:txBody>
      </p:sp>
      <p:sp>
        <p:nvSpPr>
          <p:cNvPr id="46" name="Textfeld 37">
            <a:extLst>
              <a:ext uri="{FF2B5EF4-FFF2-40B4-BE49-F238E27FC236}">
                <a16:creationId xmlns:a16="http://schemas.microsoft.com/office/drawing/2014/main" id="{6004B8FB-DB9A-48A0-96C1-19CA97549611}"/>
              </a:ext>
            </a:extLst>
          </p:cNvPr>
          <p:cNvSpPr txBox="1"/>
          <p:nvPr/>
        </p:nvSpPr>
        <p:spPr>
          <a:xfrm rot="18110173">
            <a:off x="4572449" y="1319848"/>
            <a:ext cx="1149087" cy="3178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Hox</a:t>
            </a:r>
            <a:r>
              <a:rPr lang="de-DE" sz="1400" dirty="0"/>
              <a:t> URE</a:t>
            </a:r>
          </a:p>
        </p:txBody>
      </p:sp>
      <p:sp>
        <p:nvSpPr>
          <p:cNvPr id="5" name="Accolade ouvrante 4">
            <a:extLst>
              <a:ext uri="{FF2B5EF4-FFF2-40B4-BE49-F238E27FC236}">
                <a16:creationId xmlns:a16="http://schemas.microsoft.com/office/drawing/2014/main" id="{FA340DE1-84DE-4C72-BD56-43B403637D63}"/>
              </a:ext>
            </a:extLst>
          </p:cNvPr>
          <p:cNvSpPr/>
          <p:nvPr/>
        </p:nvSpPr>
        <p:spPr>
          <a:xfrm rot="5400000">
            <a:off x="4708070" y="679964"/>
            <a:ext cx="113802" cy="1149278"/>
          </a:xfrm>
          <a:prstGeom prst="leftBrac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278A3599-B75B-425E-81D7-057FC329C66F}"/>
              </a:ext>
            </a:extLst>
          </p:cNvPr>
          <p:cNvSpPr txBox="1"/>
          <p:nvPr/>
        </p:nvSpPr>
        <p:spPr>
          <a:xfrm>
            <a:off x="4131302" y="789730"/>
            <a:ext cx="12653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1st </a:t>
            </a:r>
            <a:r>
              <a:rPr lang="fr-FR" sz="1600" b="1" dirty="0" err="1"/>
              <a:t>Replicate</a:t>
            </a:r>
            <a:endParaRPr lang="fr-FR" sz="1600" b="1" dirty="0"/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79C056BC-B694-4B6F-9E42-DBFC1353E9E2}"/>
              </a:ext>
            </a:extLst>
          </p:cNvPr>
          <p:cNvSpPr txBox="1"/>
          <p:nvPr/>
        </p:nvSpPr>
        <p:spPr>
          <a:xfrm>
            <a:off x="5559849" y="789913"/>
            <a:ext cx="13365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2nd </a:t>
            </a:r>
            <a:r>
              <a:rPr lang="fr-FR" sz="1600" b="1" dirty="0" err="1"/>
              <a:t>Replicate</a:t>
            </a:r>
            <a:endParaRPr lang="fr-FR" sz="1600" b="1" dirty="0"/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BBB28480-110E-45D2-B12D-20FB6A0C8C3B}"/>
              </a:ext>
            </a:extLst>
          </p:cNvPr>
          <p:cNvSpPr txBox="1"/>
          <p:nvPr/>
        </p:nvSpPr>
        <p:spPr>
          <a:xfrm>
            <a:off x="6963616" y="791814"/>
            <a:ext cx="12972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3rd </a:t>
            </a:r>
            <a:r>
              <a:rPr lang="fr-FR" sz="1600" b="1" dirty="0" err="1"/>
              <a:t>Replicate</a:t>
            </a:r>
            <a:endParaRPr lang="fr-FR" sz="1600" b="1" dirty="0"/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327DF7C1-6734-46D2-8154-583ED8E2995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8872" y="2011077"/>
            <a:ext cx="6752758" cy="4722871"/>
          </a:xfrm>
          <a:prstGeom prst="rect">
            <a:avLst/>
          </a:prstGeom>
        </p:spPr>
      </p:pic>
      <p:sp>
        <p:nvSpPr>
          <p:cNvPr id="28" name="Accolade ouvrante 27">
            <a:extLst>
              <a:ext uri="{FF2B5EF4-FFF2-40B4-BE49-F238E27FC236}">
                <a16:creationId xmlns:a16="http://schemas.microsoft.com/office/drawing/2014/main" id="{FC7018B7-F0B5-4215-AFB4-81D97E13C314}"/>
              </a:ext>
            </a:extLst>
          </p:cNvPr>
          <p:cNvSpPr/>
          <p:nvPr/>
        </p:nvSpPr>
        <p:spPr>
          <a:xfrm rot="5400000">
            <a:off x="6141333" y="672220"/>
            <a:ext cx="113802" cy="1149278"/>
          </a:xfrm>
          <a:prstGeom prst="leftBrac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Accolade ouvrante 28">
            <a:extLst>
              <a:ext uri="{FF2B5EF4-FFF2-40B4-BE49-F238E27FC236}">
                <a16:creationId xmlns:a16="http://schemas.microsoft.com/office/drawing/2014/main" id="{44AA5661-CF21-4235-8576-3E1B0B74C324}"/>
              </a:ext>
            </a:extLst>
          </p:cNvPr>
          <p:cNvSpPr/>
          <p:nvPr/>
        </p:nvSpPr>
        <p:spPr>
          <a:xfrm rot="5400000">
            <a:off x="7599743" y="672220"/>
            <a:ext cx="113802" cy="1149278"/>
          </a:xfrm>
          <a:prstGeom prst="leftBrac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445926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Breitbild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AAAA E+ Optima</vt:lpstr>
      <vt:lpstr>Arial</vt:lpstr>
      <vt:lpstr>Calibri</vt:lpstr>
      <vt:lpstr>Calibri Light</vt:lpstr>
      <vt:lpstr>Thème 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eting 22.04</dc:title>
  <dc:creator>Füsun Boydere</dc:creator>
  <cp:lastModifiedBy>Alexander Bender</cp:lastModifiedBy>
  <cp:revision>6</cp:revision>
  <dcterms:created xsi:type="dcterms:W3CDTF">2022-04-22T11:29:40Z</dcterms:created>
  <dcterms:modified xsi:type="dcterms:W3CDTF">2024-08-29T18:15:38Z</dcterms:modified>
</cp:coreProperties>
</file>